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90" r:id="rId2"/>
  </p:sldIdLst>
  <p:sldSz cx="9144000" cy="6858000" type="letter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6918E574-B4D3-4E64-9728-03EE1DA043D5}">
          <p14:sldIdLst>
            <p14:sldId id="290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hampaseuth Thapa" initials="KT" lastIdx="1" clrIdx="0">
    <p:extLst>
      <p:ext uri="{19B8F6BF-5375-455C-9EA6-DF929625EA0E}">
        <p15:presenceInfo xmlns:p15="http://schemas.microsoft.com/office/powerpoint/2012/main" userId="Khampaseuth Thap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14" autoAdjust="0"/>
    <p:restoredTop sz="92286" autoAdjust="0"/>
  </p:normalViewPr>
  <p:slideViewPr>
    <p:cSldViewPr snapToGrid="0">
      <p:cViewPr varScale="1">
        <p:scale>
          <a:sx n="54" d="100"/>
          <a:sy n="54" d="100"/>
        </p:scale>
        <p:origin x="1574" y="6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027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992B88-925B-4B5C-A108-3A3EDC49E3CA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028950" y="857250"/>
            <a:ext cx="30861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5EE7DB-55AF-4A23-BE09-0DB13C12E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534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B3A1D-892D-46C6-9245-EF237D1A9358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A74AA-21D2-47BE-BE35-A2E1D514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379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B3A1D-892D-46C6-9245-EF237D1A9358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A74AA-21D2-47BE-BE35-A2E1D514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3912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B3A1D-892D-46C6-9245-EF237D1A9358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A74AA-21D2-47BE-BE35-A2E1D514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448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B3A1D-892D-46C6-9245-EF237D1A9358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A74AA-21D2-47BE-BE35-A2E1D514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871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B3A1D-892D-46C6-9245-EF237D1A9358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A74AA-21D2-47BE-BE35-A2E1D514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163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B3A1D-892D-46C6-9245-EF237D1A9358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A74AA-21D2-47BE-BE35-A2E1D514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923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B3A1D-892D-46C6-9245-EF237D1A9358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A74AA-21D2-47BE-BE35-A2E1D514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746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B3A1D-892D-46C6-9245-EF237D1A9358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A74AA-21D2-47BE-BE35-A2E1D514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529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B3A1D-892D-46C6-9245-EF237D1A9358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A74AA-21D2-47BE-BE35-A2E1D514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6397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B3A1D-892D-46C6-9245-EF237D1A9358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A74AA-21D2-47BE-BE35-A2E1D514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30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B3A1D-892D-46C6-9245-EF237D1A9358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A74AA-21D2-47BE-BE35-A2E1D514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597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7B3A1D-892D-46C6-9245-EF237D1A9358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A74AA-21D2-47BE-BE35-A2E1D514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826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8" name="Group 157"/>
          <p:cNvGrpSpPr/>
          <p:nvPr/>
        </p:nvGrpSpPr>
        <p:grpSpPr>
          <a:xfrm>
            <a:off x="3572753" y="3433066"/>
            <a:ext cx="241905" cy="141477"/>
            <a:chOff x="2985363" y="2996832"/>
            <a:chExt cx="322540" cy="188636"/>
          </a:xfrm>
        </p:grpSpPr>
        <p:sp>
          <p:nvSpPr>
            <p:cNvPr id="159" name="Oval 158"/>
            <p:cNvSpPr/>
            <p:nvPr/>
          </p:nvSpPr>
          <p:spPr>
            <a:xfrm>
              <a:off x="2985363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160" name="Oval 159"/>
            <p:cNvSpPr/>
            <p:nvPr/>
          </p:nvSpPr>
          <p:spPr>
            <a:xfrm>
              <a:off x="3144249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</p:grpSp>
      <p:grpSp>
        <p:nvGrpSpPr>
          <p:cNvPr id="161" name="Group 160"/>
          <p:cNvGrpSpPr/>
          <p:nvPr/>
        </p:nvGrpSpPr>
        <p:grpSpPr>
          <a:xfrm>
            <a:off x="3819437" y="3433066"/>
            <a:ext cx="241905" cy="141477"/>
            <a:chOff x="2985363" y="2996832"/>
            <a:chExt cx="322540" cy="188636"/>
          </a:xfrm>
        </p:grpSpPr>
        <p:sp>
          <p:nvSpPr>
            <p:cNvPr id="162" name="Oval 161"/>
            <p:cNvSpPr/>
            <p:nvPr/>
          </p:nvSpPr>
          <p:spPr>
            <a:xfrm>
              <a:off x="2985363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163" name="Oval 162"/>
            <p:cNvSpPr/>
            <p:nvPr/>
          </p:nvSpPr>
          <p:spPr>
            <a:xfrm>
              <a:off x="3144249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</p:grpSp>
      <p:grpSp>
        <p:nvGrpSpPr>
          <p:cNvPr id="164" name="Group 163"/>
          <p:cNvGrpSpPr/>
          <p:nvPr/>
        </p:nvGrpSpPr>
        <p:grpSpPr>
          <a:xfrm>
            <a:off x="4077551" y="3433066"/>
            <a:ext cx="241905" cy="141477"/>
            <a:chOff x="2985363" y="2996832"/>
            <a:chExt cx="322540" cy="188636"/>
          </a:xfrm>
        </p:grpSpPr>
        <p:sp>
          <p:nvSpPr>
            <p:cNvPr id="165" name="Oval 164"/>
            <p:cNvSpPr/>
            <p:nvPr/>
          </p:nvSpPr>
          <p:spPr>
            <a:xfrm>
              <a:off x="2985363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166" name="Oval 165"/>
            <p:cNvSpPr/>
            <p:nvPr/>
          </p:nvSpPr>
          <p:spPr>
            <a:xfrm>
              <a:off x="3144249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</p:grpSp>
      <p:grpSp>
        <p:nvGrpSpPr>
          <p:cNvPr id="167" name="Group 166"/>
          <p:cNvGrpSpPr/>
          <p:nvPr/>
        </p:nvGrpSpPr>
        <p:grpSpPr>
          <a:xfrm>
            <a:off x="4324235" y="3433066"/>
            <a:ext cx="241905" cy="141477"/>
            <a:chOff x="2985363" y="2996832"/>
            <a:chExt cx="322540" cy="188636"/>
          </a:xfrm>
        </p:grpSpPr>
        <p:sp>
          <p:nvSpPr>
            <p:cNvPr id="168" name="Oval 167"/>
            <p:cNvSpPr/>
            <p:nvPr/>
          </p:nvSpPr>
          <p:spPr>
            <a:xfrm>
              <a:off x="2985363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169" name="Oval 168"/>
            <p:cNvSpPr/>
            <p:nvPr/>
          </p:nvSpPr>
          <p:spPr>
            <a:xfrm>
              <a:off x="3144249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</p:grpSp>
      <p:grpSp>
        <p:nvGrpSpPr>
          <p:cNvPr id="170" name="Group 169"/>
          <p:cNvGrpSpPr/>
          <p:nvPr/>
        </p:nvGrpSpPr>
        <p:grpSpPr>
          <a:xfrm>
            <a:off x="4570919" y="3433066"/>
            <a:ext cx="241905" cy="141477"/>
            <a:chOff x="2985363" y="2996832"/>
            <a:chExt cx="322540" cy="188636"/>
          </a:xfrm>
        </p:grpSpPr>
        <p:sp>
          <p:nvSpPr>
            <p:cNvPr id="171" name="Oval 170"/>
            <p:cNvSpPr/>
            <p:nvPr/>
          </p:nvSpPr>
          <p:spPr>
            <a:xfrm>
              <a:off x="2985363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172" name="Oval 171"/>
            <p:cNvSpPr/>
            <p:nvPr/>
          </p:nvSpPr>
          <p:spPr>
            <a:xfrm>
              <a:off x="3144249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</p:grpSp>
      <p:grpSp>
        <p:nvGrpSpPr>
          <p:cNvPr id="173" name="Group 172"/>
          <p:cNvGrpSpPr/>
          <p:nvPr/>
        </p:nvGrpSpPr>
        <p:grpSpPr>
          <a:xfrm>
            <a:off x="4829033" y="3433066"/>
            <a:ext cx="241905" cy="141477"/>
            <a:chOff x="2985363" y="2996832"/>
            <a:chExt cx="322540" cy="188636"/>
          </a:xfrm>
        </p:grpSpPr>
        <p:sp>
          <p:nvSpPr>
            <p:cNvPr id="174" name="Oval 173"/>
            <p:cNvSpPr/>
            <p:nvPr/>
          </p:nvSpPr>
          <p:spPr>
            <a:xfrm>
              <a:off x="2985363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175" name="Oval 174"/>
            <p:cNvSpPr/>
            <p:nvPr/>
          </p:nvSpPr>
          <p:spPr>
            <a:xfrm>
              <a:off x="3144249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1376168" y="417803"/>
            <a:ext cx="583878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b="1" dirty="0">
                <a:solidFill>
                  <a:prstClr val="black"/>
                </a:solidFill>
              </a:rPr>
              <a:t>Day 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288405" y="3549116"/>
            <a:ext cx="672043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b="1" dirty="0">
                <a:solidFill>
                  <a:prstClr val="black"/>
                </a:solidFill>
              </a:rPr>
              <a:t>Day 11</a:t>
            </a:r>
          </a:p>
        </p:txBody>
      </p:sp>
      <p:grpSp>
        <p:nvGrpSpPr>
          <p:cNvPr id="176" name="Group 175"/>
          <p:cNvGrpSpPr/>
          <p:nvPr/>
        </p:nvGrpSpPr>
        <p:grpSpPr>
          <a:xfrm>
            <a:off x="1899512" y="611032"/>
            <a:ext cx="1511476" cy="465515"/>
            <a:chOff x="2966313" y="2804011"/>
            <a:chExt cx="2015302" cy="620686"/>
          </a:xfrm>
        </p:grpSpPr>
        <p:sp>
          <p:nvSpPr>
            <p:cNvPr id="11" name="Oval 10"/>
            <p:cNvSpPr/>
            <p:nvPr/>
          </p:nvSpPr>
          <p:spPr>
            <a:xfrm>
              <a:off x="2985363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12" name="Oval 11"/>
            <p:cNvSpPr/>
            <p:nvPr/>
          </p:nvSpPr>
          <p:spPr>
            <a:xfrm>
              <a:off x="3144249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92" name="Oval 91"/>
            <p:cNvSpPr/>
            <p:nvPr/>
          </p:nvSpPr>
          <p:spPr>
            <a:xfrm>
              <a:off x="3314275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93" name="Oval 92"/>
            <p:cNvSpPr/>
            <p:nvPr/>
          </p:nvSpPr>
          <p:spPr>
            <a:xfrm>
              <a:off x="3473161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98" name="Oval 97"/>
            <p:cNvSpPr/>
            <p:nvPr/>
          </p:nvSpPr>
          <p:spPr>
            <a:xfrm>
              <a:off x="3643187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99" name="Oval 98"/>
            <p:cNvSpPr/>
            <p:nvPr/>
          </p:nvSpPr>
          <p:spPr>
            <a:xfrm>
              <a:off x="3802073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101" name="Oval 100"/>
            <p:cNvSpPr/>
            <p:nvPr/>
          </p:nvSpPr>
          <p:spPr>
            <a:xfrm>
              <a:off x="3972099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102" name="Oval 101"/>
            <p:cNvSpPr/>
            <p:nvPr/>
          </p:nvSpPr>
          <p:spPr>
            <a:xfrm>
              <a:off x="4130985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104" name="Oval 103"/>
            <p:cNvSpPr/>
            <p:nvPr/>
          </p:nvSpPr>
          <p:spPr>
            <a:xfrm>
              <a:off x="4301011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105" name="Oval 104"/>
            <p:cNvSpPr/>
            <p:nvPr/>
          </p:nvSpPr>
          <p:spPr>
            <a:xfrm>
              <a:off x="4459897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107" name="Oval 106"/>
            <p:cNvSpPr/>
            <p:nvPr/>
          </p:nvSpPr>
          <p:spPr>
            <a:xfrm>
              <a:off x="4629921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108" name="Oval 107"/>
            <p:cNvSpPr/>
            <p:nvPr/>
          </p:nvSpPr>
          <p:spPr>
            <a:xfrm>
              <a:off x="4788807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2966313" y="3190554"/>
              <a:ext cx="2015302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27" name="Flowchart: Magnetic Disk 26"/>
            <p:cNvSpPr/>
            <p:nvPr/>
          </p:nvSpPr>
          <p:spPr>
            <a:xfrm>
              <a:off x="2966313" y="2804011"/>
              <a:ext cx="2015302" cy="620686"/>
            </a:xfrm>
            <a:prstGeom prst="flowChartMagneticDisk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1" dirty="0">
                <a:solidFill>
                  <a:prstClr val="white"/>
                </a:solidFill>
              </a:endParaRPr>
            </a:p>
          </p:txBody>
        </p:sp>
      </p:grpSp>
      <p:sp>
        <p:nvSpPr>
          <p:cNvPr id="45" name="TextBox 44"/>
          <p:cNvSpPr txBox="1"/>
          <p:nvPr/>
        </p:nvSpPr>
        <p:spPr>
          <a:xfrm>
            <a:off x="-115810" y="1656446"/>
            <a:ext cx="1332653" cy="1131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1" dirty="0" smtClean="0">
                <a:solidFill>
                  <a:prstClr val="black"/>
                </a:solidFill>
              </a:rPr>
              <a:t>*Adipocyte </a:t>
            </a:r>
            <a:endParaRPr lang="en-US" sz="1351" dirty="0">
              <a:solidFill>
                <a:prstClr val="black"/>
              </a:solidFill>
            </a:endParaRPr>
          </a:p>
          <a:p>
            <a:pPr algn="ctr"/>
            <a:r>
              <a:rPr lang="en-US" sz="1351" dirty="0">
                <a:solidFill>
                  <a:prstClr val="black"/>
                </a:solidFill>
              </a:rPr>
              <a:t>Differentiation for 10 </a:t>
            </a:r>
            <a:r>
              <a:rPr lang="en-US" sz="1351" dirty="0" smtClean="0">
                <a:solidFill>
                  <a:prstClr val="black"/>
                </a:solidFill>
              </a:rPr>
              <a:t>days on </a:t>
            </a:r>
            <a:r>
              <a:rPr lang="en-US" sz="1351" dirty="0" err="1" smtClean="0">
                <a:solidFill>
                  <a:prstClr val="black"/>
                </a:solidFill>
              </a:rPr>
              <a:t>transwell</a:t>
            </a:r>
            <a:r>
              <a:rPr lang="en-US" sz="1351" dirty="0" smtClean="0">
                <a:solidFill>
                  <a:prstClr val="black"/>
                </a:solidFill>
              </a:rPr>
              <a:t> plate inserts</a:t>
            </a:r>
            <a:endParaRPr lang="en-US" sz="1351" dirty="0">
              <a:solidFill>
                <a:prstClr val="black"/>
              </a:solidFill>
            </a:endParaRPr>
          </a:p>
        </p:txBody>
      </p:sp>
      <p:cxnSp>
        <p:nvCxnSpPr>
          <p:cNvPr id="47" name="Elbow Connector 46"/>
          <p:cNvCxnSpPr/>
          <p:nvPr/>
        </p:nvCxnSpPr>
        <p:spPr>
          <a:xfrm rot="10800000" flipV="1">
            <a:off x="1277518" y="619804"/>
            <a:ext cx="87765" cy="3108960"/>
          </a:xfrm>
          <a:prstGeom prst="bentConnector3">
            <a:avLst>
              <a:gd name="adj1" fmla="val 295351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" name="Group 4"/>
          <p:cNvGrpSpPr/>
          <p:nvPr/>
        </p:nvGrpSpPr>
        <p:grpSpPr>
          <a:xfrm>
            <a:off x="4355512" y="2087965"/>
            <a:ext cx="1511476" cy="465515"/>
            <a:chOff x="4355512" y="2225125"/>
            <a:chExt cx="1511476" cy="465515"/>
          </a:xfrm>
        </p:grpSpPr>
        <p:grpSp>
          <p:nvGrpSpPr>
            <p:cNvPr id="112" name="Group 111"/>
            <p:cNvGrpSpPr/>
            <p:nvPr/>
          </p:nvGrpSpPr>
          <p:grpSpPr>
            <a:xfrm rot="11766775">
              <a:off x="4800914" y="2528334"/>
              <a:ext cx="192471" cy="144341"/>
              <a:chOff x="4878896" y="4468974"/>
              <a:chExt cx="252661" cy="192454"/>
            </a:xfrm>
          </p:grpSpPr>
          <p:sp>
            <p:nvSpPr>
              <p:cNvPr id="110" name="Freeform 109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111" name="Oval 110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 dirty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13" name="Group 112"/>
            <p:cNvGrpSpPr/>
            <p:nvPr/>
          </p:nvGrpSpPr>
          <p:grpSpPr>
            <a:xfrm rot="11181539">
              <a:off x="4386024" y="2506894"/>
              <a:ext cx="192471" cy="144341"/>
              <a:chOff x="4878896" y="4468974"/>
              <a:chExt cx="252661" cy="192454"/>
            </a:xfrm>
          </p:grpSpPr>
          <p:sp>
            <p:nvSpPr>
              <p:cNvPr id="114" name="Freeform 113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115" name="Oval 114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 dirty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16" name="Group 115"/>
            <p:cNvGrpSpPr/>
            <p:nvPr/>
          </p:nvGrpSpPr>
          <p:grpSpPr>
            <a:xfrm>
              <a:off x="4593469" y="2523886"/>
              <a:ext cx="192471" cy="144341"/>
              <a:chOff x="4878896" y="4468974"/>
              <a:chExt cx="252661" cy="192454"/>
            </a:xfrm>
          </p:grpSpPr>
          <p:sp>
            <p:nvSpPr>
              <p:cNvPr id="117" name="Freeform 116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118" name="Oval 117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 dirty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19" name="Group 118"/>
            <p:cNvGrpSpPr/>
            <p:nvPr/>
          </p:nvGrpSpPr>
          <p:grpSpPr>
            <a:xfrm rot="19578349">
              <a:off x="5008358" y="2537017"/>
              <a:ext cx="192471" cy="144341"/>
              <a:chOff x="4878896" y="4468974"/>
              <a:chExt cx="252661" cy="192454"/>
            </a:xfrm>
          </p:grpSpPr>
          <p:sp>
            <p:nvSpPr>
              <p:cNvPr id="120" name="Freeform 119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121" name="Oval 120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 dirty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22" name="Group 121"/>
            <p:cNvGrpSpPr/>
            <p:nvPr/>
          </p:nvGrpSpPr>
          <p:grpSpPr>
            <a:xfrm rot="8793276">
              <a:off x="5215803" y="2529675"/>
              <a:ext cx="192471" cy="144341"/>
              <a:chOff x="4878896" y="4468974"/>
              <a:chExt cx="252661" cy="192454"/>
            </a:xfrm>
          </p:grpSpPr>
          <p:sp>
            <p:nvSpPr>
              <p:cNvPr id="123" name="Freeform 122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124" name="Oval 123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 dirty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25" name="Group 124"/>
            <p:cNvGrpSpPr/>
            <p:nvPr/>
          </p:nvGrpSpPr>
          <p:grpSpPr>
            <a:xfrm rot="19708783">
              <a:off x="5423248" y="2535461"/>
              <a:ext cx="192471" cy="144341"/>
              <a:chOff x="4878896" y="4468974"/>
              <a:chExt cx="252661" cy="192454"/>
            </a:xfrm>
          </p:grpSpPr>
          <p:sp>
            <p:nvSpPr>
              <p:cNvPr id="126" name="Freeform 125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127" name="Oval 126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 dirty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28" name="Group 127"/>
            <p:cNvGrpSpPr/>
            <p:nvPr/>
          </p:nvGrpSpPr>
          <p:grpSpPr>
            <a:xfrm rot="20706418">
              <a:off x="5630692" y="2526781"/>
              <a:ext cx="192471" cy="144341"/>
              <a:chOff x="4878896" y="4468974"/>
              <a:chExt cx="252661" cy="192454"/>
            </a:xfrm>
          </p:grpSpPr>
          <p:sp>
            <p:nvSpPr>
              <p:cNvPr id="129" name="Freeform 128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130" name="Oval 129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 dirty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72" name="Group 71"/>
            <p:cNvGrpSpPr/>
            <p:nvPr/>
          </p:nvGrpSpPr>
          <p:grpSpPr>
            <a:xfrm>
              <a:off x="4355512" y="2225125"/>
              <a:ext cx="1511476" cy="465515"/>
              <a:chOff x="5461863" y="2244398"/>
              <a:chExt cx="2015302" cy="620686"/>
            </a:xfrm>
          </p:grpSpPr>
          <p:cxnSp>
            <p:nvCxnSpPr>
              <p:cNvPr id="57" name="Straight Connector 56"/>
              <p:cNvCxnSpPr/>
              <p:nvPr/>
            </p:nvCxnSpPr>
            <p:spPr>
              <a:xfrm>
                <a:off x="5461863" y="2630941"/>
                <a:ext cx="2015302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58" name="Flowchart: Magnetic Disk 57"/>
              <p:cNvSpPr/>
              <p:nvPr/>
            </p:nvSpPr>
            <p:spPr>
              <a:xfrm>
                <a:off x="5461863" y="2244398"/>
                <a:ext cx="2015302" cy="620686"/>
              </a:xfrm>
              <a:prstGeom prst="flowChartMagneticDisk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 dirty="0">
                  <a:solidFill>
                    <a:prstClr val="white"/>
                  </a:solidFill>
                </a:endParaRPr>
              </a:p>
            </p:txBody>
          </p:sp>
        </p:grpSp>
      </p:grpSp>
      <p:sp>
        <p:nvSpPr>
          <p:cNvPr id="71" name="TextBox 70"/>
          <p:cNvSpPr txBox="1"/>
          <p:nvPr/>
        </p:nvSpPr>
        <p:spPr>
          <a:xfrm>
            <a:off x="6849337" y="2104239"/>
            <a:ext cx="583878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b="1" dirty="0">
                <a:solidFill>
                  <a:prstClr val="black"/>
                </a:solidFill>
              </a:rPr>
              <a:t>Day 7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6849337" y="2825096"/>
            <a:ext cx="672043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b="1" dirty="0">
                <a:solidFill>
                  <a:prstClr val="black"/>
                </a:solidFill>
              </a:rPr>
              <a:t>Day 10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4121901" y="4610329"/>
            <a:ext cx="672043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b="1" dirty="0">
                <a:solidFill>
                  <a:prstClr val="black"/>
                </a:solidFill>
              </a:rPr>
              <a:t>Day 12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6849337" y="3537686"/>
            <a:ext cx="672043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b="1" dirty="0">
                <a:solidFill>
                  <a:prstClr val="black"/>
                </a:solidFill>
              </a:rPr>
              <a:t>Day 11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7465511" y="2104239"/>
            <a:ext cx="1533368" cy="5080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dirty="0">
                <a:solidFill>
                  <a:prstClr val="black"/>
                </a:solidFill>
              </a:rPr>
              <a:t>Begin macrophage </a:t>
            </a:r>
          </a:p>
          <a:p>
            <a:r>
              <a:rPr lang="en-US" sz="1351" dirty="0">
                <a:solidFill>
                  <a:prstClr val="black"/>
                </a:solidFill>
              </a:rPr>
              <a:t>differentiation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7465511" y="2825096"/>
            <a:ext cx="1642947" cy="7159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1" dirty="0">
                <a:solidFill>
                  <a:prstClr val="black"/>
                </a:solidFill>
              </a:rPr>
              <a:t>Rest macrophages and stimulate with LPS/</a:t>
            </a:r>
            <a:r>
              <a:rPr lang="en-US" sz="1351" dirty="0" err="1">
                <a:solidFill>
                  <a:prstClr val="black"/>
                </a:solidFill>
              </a:rPr>
              <a:t>IFN</a:t>
            </a:r>
            <a:r>
              <a:rPr lang="en-US" sz="1351" dirty="0" err="1">
                <a:solidFill>
                  <a:prstClr val="black"/>
                </a:solidFill>
                <a:latin typeface="Symbol" panose="05050102010706020507" pitchFamily="18" charset="2"/>
              </a:rPr>
              <a:t>g</a:t>
            </a:r>
            <a:r>
              <a:rPr lang="en-US" sz="1351" dirty="0">
                <a:solidFill>
                  <a:prstClr val="black"/>
                </a:solidFill>
              </a:rPr>
              <a:t> or IL-4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7419304" y="3537644"/>
            <a:ext cx="1829691" cy="7159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1" dirty="0">
                <a:solidFill>
                  <a:prstClr val="black"/>
                </a:solidFill>
              </a:rPr>
              <a:t>Wash cultures and begin co-culture or continue mono-culture</a:t>
            </a:r>
          </a:p>
        </p:txBody>
      </p:sp>
      <p:grpSp>
        <p:nvGrpSpPr>
          <p:cNvPr id="133" name="Group 132"/>
          <p:cNvGrpSpPr/>
          <p:nvPr/>
        </p:nvGrpSpPr>
        <p:grpSpPr>
          <a:xfrm>
            <a:off x="3560648" y="3317698"/>
            <a:ext cx="1511476" cy="465515"/>
            <a:chOff x="5570499" y="2804011"/>
            <a:chExt cx="2015302" cy="620686"/>
          </a:xfrm>
        </p:grpSpPr>
        <p:grpSp>
          <p:nvGrpSpPr>
            <p:cNvPr id="134" name="Group 133"/>
            <p:cNvGrpSpPr/>
            <p:nvPr/>
          </p:nvGrpSpPr>
          <p:grpSpPr>
            <a:xfrm rot="11766775">
              <a:off x="6164368" y="3208289"/>
              <a:ext cx="256628" cy="192454"/>
              <a:chOff x="4878896" y="4468974"/>
              <a:chExt cx="252661" cy="192454"/>
            </a:xfrm>
          </p:grpSpPr>
          <p:sp>
            <p:nvSpPr>
              <p:cNvPr id="156" name="Freeform 155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  <p:sp>
            <p:nvSpPr>
              <p:cNvPr id="157" name="Oval 156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35" name="Group 134"/>
            <p:cNvGrpSpPr/>
            <p:nvPr/>
          </p:nvGrpSpPr>
          <p:grpSpPr>
            <a:xfrm rot="11181539">
              <a:off x="5611182" y="3179702"/>
              <a:ext cx="256628" cy="192454"/>
              <a:chOff x="4878896" y="4468974"/>
              <a:chExt cx="252661" cy="192454"/>
            </a:xfrm>
          </p:grpSpPr>
          <p:sp>
            <p:nvSpPr>
              <p:cNvPr id="154" name="Freeform 153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  <p:sp>
            <p:nvSpPr>
              <p:cNvPr id="155" name="Oval 154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36" name="Group 135"/>
            <p:cNvGrpSpPr/>
            <p:nvPr/>
          </p:nvGrpSpPr>
          <p:grpSpPr>
            <a:xfrm>
              <a:off x="5887775" y="3202359"/>
              <a:ext cx="256628" cy="192454"/>
              <a:chOff x="4878896" y="4468974"/>
              <a:chExt cx="252661" cy="192454"/>
            </a:xfrm>
          </p:grpSpPr>
          <p:sp>
            <p:nvSpPr>
              <p:cNvPr id="152" name="Freeform 151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  <p:sp>
            <p:nvSpPr>
              <p:cNvPr id="153" name="Oval 152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37" name="Group 136"/>
            <p:cNvGrpSpPr/>
            <p:nvPr/>
          </p:nvGrpSpPr>
          <p:grpSpPr>
            <a:xfrm rot="19578349">
              <a:off x="6440961" y="3219866"/>
              <a:ext cx="256628" cy="192454"/>
              <a:chOff x="4878896" y="4468974"/>
              <a:chExt cx="252661" cy="192454"/>
            </a:xfrm>
          </p:grpSpPr>
          <p:sp>
            <p:nvSpPr>
              <p:cNvPr id="150" name="Freeform 149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  <p:sp>
            <p:nvSpPr>
              <p:cNvPr id="151" name="Oval 150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38" name="Group 137"/>
            <p:cNvGrpSpPr/>
            <p:nvPr/>
          </p:nvGrpSpPr>
          <p:grpSpPr>
            <a:xfrm rot="8793276">
              <a:off x="6717554" y="3210077"/>
              <a:ext cx="256628" cy="192454"/>
              <a:chOff x="4878896" y="4468974"/>
              <a:chExt cx="252661" cy="192454"/>
            </a:xfrm>
          </p:grpSpPr>
          <p:sp>
            <p:nvSpPr>
              <p:cNvPr id="148" name="Freeform 147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  <p:sp>
            <p:nvSpPr>
              <p:cNvPr id="149" name="Oval 148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39" name="Group 138"/>
            <p:cNvGrpSpPr/>
            <p:nvPr/>
          </p:nvGrpSpPr>
          <p:grpSpPr>
            <a:xfrm rot="19708783">
              <a:off x="6994147" y="3217792"/>
              <a:ext cx="256628" cy="192454"/>
              <a:chOff x="4878896" y="4468974"/>
              <a:chExt cx="252661" cy="192454"/>
            </a:xfrm>
          </p:grpSpPr>
          <p:sp>
            <p:nvSpPr>
              <p:cNvPr id="146" name="Freeform 145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  <p:sp>
            <p:nvSpPr>
              <p:cNvPr id="147" name="Oval 146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40" name="Group 139"/>
            <p:cNvGrpSpPr/>
            <p:nvPr/>
          </p:nvGrpSpPr>
          <p:grpSpPr>
            <a:xfrm rot="20706418">
              <a:off x="7270739" y="3206218"/>
              <a:ext cx="256628" cy="192454"/>
              <a:chOff x="4878896" y="4468974"/>
              <a:chExt cx="252661" cy="192454"/>
            </a:xfrm>
          </p:grpSpPr>
          <p:sp>
            <p:nvSpPr>
              <p:cNvPr id="144" name="Freeform 143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  <p:sp>
            <p:nvSpPr>
              <p:cNvPr id="145" name="Oval 144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41" name="Group 140"/>
            <p:cNvGrpSpPr/>
            <p:nvPr/>
          </p:nvGrpSpPr>
          <p:grpSpPr>
            <a:xfrm>
              <a:off x="5570499" y="2804011"/>
              <a:ext cx="2015302" cy="620686"/>
              <a:chOff x="5461863" y="2244398"/>
              <a:chExt cx="2015302" cy="620686"/>
            </a:xfrm>
          </p:grpSpPr>
          <p:cxnSp>
            <p:nvCxnSpPr>
              <p:cNvPr id="142" name="Straight Connector 141"/>
              <p:cNvCxnSpPr/>
              <p:nvPr/>
            </p:nvCxnSpPr>
            <p:spPr>
              <a:xfrm>
                <a:off x="5461863" y="2630941"/>
                <a:ext cx="2015302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143" name="Flowchart: Magnetic Disk 142"/>
              <p:cNvSpPr/>
              <p:nvPr/>
            </p:nvSpPr>
            <p:spPr>
              <a:xfrm>
                <a:off x="5461863" y="2244398"/>
                <a:ext cx="2015302" cy="620686"/>
              </a:xfrm>
              <a:prstGeom prst="flowChartMagneticDisk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</p:grpSp>
      </p:grpSp>
      <p:sp>
        <p:nvSpPr>
          <p:cNvPr id="184" name="TextBox 183"/>
          <p:cNvSpPr txBox="1"/>
          <p:nvPr/>
        </p:nvSpPr>
        <p:spPr>
          <a:xfrm>
            <a:off x="2498760" y="4888964"/>
            <a:ext cx="3832074" cy="508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1" dirty="0">
                <a:solidFill>
                  <a:prstClr val="black"/>
                </a:solidFill>
              </a:rPr>
              <a:t>1. </a:t>
            </a:r>
            <a:r>
              <a:rPr lang="en-US" sz="1351" dirty="0" smtClean="0">
                <a:solidFill>
                  <a:prstClr val="black"/>
                </a:solidFill>
              </a:rPr>
              <a:t>Collect culture media to assess cytokine secretion</a:t>
            </a:r>
          </a:p>
          <a:p>
            <a:r>
              <a:rPr lang="en-US" sz="1351" dirty="0" smtClean="0">
                <a:solidFill>
                  <a:prstClr val="black"/>
                </a:solidFill>
              </a:rPr>
              <a:t>2. Harvest </a:t>
            </a:r>
            <a:r>
              <a:rPr lang="en-US" sz="1351" dirty="0">
                <a:solidFill>
                  <a:prstClr val="black"/>
                </a:solidFill>
              </a:rPr>
              <a:t>macrophages for transcriptional profiling</a:t>
            </a:r>
          </a:p>
        </p:txBody>
      </p:sp>
      <p:grpSp>
        <p:nvGrpSpPr>
          <p:cNvPr id="106" name="Group 105"/>
          <p:cNvGrpSpPr/>
          <p:nvPr/>
        </p:nvGrpSpPr>
        <p:grpSpPr>
          <a:xfrm>
            <a:off x="1905690" y="3317698"/>
            <a:ext cx="1511476" cy="465515"/>
            <a:chOff x="2966313" y="2804011"/>
            <a:chExt cx="2015302" cy="620686"/>
          </a:xfrm>
        </p:grpSpPr>
        <p:sp>
          <p:nvSpPr>
            <p:cNvPr id="109" name="Oval 108"/>
            <p:cNvSpPr/>
            <p:nvPr/>
          </p:nvSpPr>
          <p:spPr>
            <a:xfrm>
              <a:off x="2985363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>
                <a:solidFill>
                  <a:prstClr val="white"/>
                </a:solidFill>
              </a:endParaRPr>
            </a:p>
          </p:txBody>
        </p:sp>
        <p:sp>
          <p:nvSpPr>
            <p:cNvPr id="131" name="Oval 130"/>
            <p:cNvSpPr/>
            <p:nvPr/>
          </p:nvSpPr>
          <p:spPr>
            <a:xfrm>
              <a:off x="3144249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>
                <a:solidFill>
                  <a:prstClr val="white"/>
                </a:solidFill>
              </a:endParaRPr>
            </a:p>
          </p:txBody>
        </p:sp>
        <p:sp>
          <p:nvSpPr>
            <p:cNvPr id="177" name="Oval 176"/>
            <p:cNvSpPr/>
            <p:nvPr/>
          </p:nvSpPr>
          <p:spPr>
            <a:xfrm>
              <a:off x="3314275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>
                <a:solidFill>
                  <a:prstClr val="white"/>
                </a:solidFill>
              </a:endParaRPr>
            </a:p>
          </p:txBody>
        </p:sp>
        <p:sp>
          <p:nvSpPr>
            <p:cNvPr id="186" name="Oval 185"/>
            <p:cNvSpPr/>
            <p:nvPr/>
          </p:nvSpPr>
          <p:spPr>
            <a:xfrm>
              <a:off x="3473161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>
                <a:solidFill>
                  <a:prstClr val="white"/>
                </a:solidFill>
              </a:endParaRPr>
            </a:p>
          </p:txBody>
        </p:sp>
        <p:sp>
          <p:nvSpPr>
            <p:cNvPr id="188" name="Oval 187"/>
            <p:cNvSpPr/>
            <p:nvPr/>
          </p:nvSpPr>
          <p:spPr>
            <a:xfrm>
              <a:off x="3643187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>
                <a:solidFill>
                  <a:prstClr val="white"/>
                </a:solidFill>
              </a:endParaRPr>
            </a:p>
          </p:txBody>
        </p:sp>
        <p:sp>
          <p:nvSpPr>
            <p:cNvPr id="190" name="Oval 189"/>
            <p:cNvSpPr/>
            <p:nvPr/>
          </p:nvSpPr>
          <p:spPr>
            <a:xfrm>
              <a:off x="3802073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>
                <a:solidFill>
                  <a:prstClr val="white"/>
                </a:solidFill>
              </a:endParaRPr>
            </a:p>
          </p:txBody>
        </p:sp>
        <p:sp>
          <p:nvSpPr>
            <p:cNvPr id="191" name="Oval 190"/>
            <p:cNvSpPr/>
            <p:nvPr/>
          </p:nvSpPr>
          <p:spPr>
            <a:xfrm>
              <a:off x="3972099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>
                <a:solidFill>
                  <a:prstClr val="white"/>
                </a:solidFill>
              </a:endParaRPr>
            </a:p>
          </p:txBody>
        </p:sp>
        <p:sp>
          <p:nvSpPr>
            <p:cNvPr id="192" name="Oval 191"/>
            <p:cNvSpPr/>
            <p:nvPr/>
          </p:nvSpPr>
          <p:spPr>
            <a:xfrm>
              <a:off x="4130985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>
                <a:solidFill>
                  <a:prstClr val="white"/>
                </a:solidFill>
              </a:endParaRPr>
            </a:p>
          </p:txBody>
        </p:sp>
        <p:sp>
          <p:nvSpPr>
            <p:cNvPr id="193" name="Oval 192"/>
            <p:cNvSpPr/>
            <p:nvPr/>
          </p:nvSpPr>
          <p:spPr>
            <a:xfrm>
              <a:off x="4301011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>
                <a:solidFill>
                  <a:prstClr val="white"/>
                </a:solidFill>
              </a:endParaRPr>
            </a:p>
          </p:txBody>
        </p:sp>
        <p:sp>
          <p:nvSpPr>
            <p:cNvPr id="194" name="Oval 193"/>
            <p:cNvSpPr/>
            <p:nvPr/>
          </p:nvSpPr>
          <p:spPr>
            <a:xfrm>
              <a:off x="4459897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>
                <a:solidFill>
                  <a:prstClr val="white"/>
                </a:solidFill>
              </a:endParaRPr>
            </a:p>
          </p:txBody>
        </p:sp>
        <p:sp>
          <p:nvSpPr>
            <p:cNvPr id="195" name="Oval 194"/>
            <p:cNvSpPr/>
            <p:nvPr/>
          </p:nvSpPr>
          <p:spPr>
            <a:xfrm>
              <a:off x="4629921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>
                <a:solidFill>
                  <a:prstClr val="white"/>
                </a:solidFill>
              </a:endParaRPr>
            </a:p>
          </p:txBody>
        </p:sp>
        <p:sp>
          <p:nvSpPr>
            <p:cNvPr id="196" name="Oval 195"/>
            <p:cNvSpPr/>
            <p:nvPr/>
          </p:nvSpPr>
          <p:spPr>
            <a:xfrm>
              <a:off x="4788807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>
                <a:solidFill>
                  <a:prstClr val="white"/>
                </a:solidFill>
              </a:endParaRPr>
            </a:p>
          </p:txBody>
        </p:sp>
        <p:cxnSp>
          <p:nvCxnSpPr>
            <p:cNvPr id="197" name="Straight Connector 196"/>
            <p:cNvCxnSpPr/>
            <p:nvPr/>
          </p:nvCxnSpPr>
          <p:spPr>
            <a:xfrm>
              <a:off x="2966313" y="3190554"/>
              <a:ext cx="2015302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98" name="Flowchart: Magnetic Disk 197"/>
            <p:cNvSpPr/>
            <p:nvPr/>
          </p:nvSpPr>
          <p:spPr>
            <a:xfrm>
              <a:off x="2966313" y="2804011"/>
              <a:ext cx="2015302" cy="620686"/>
            </a:xfrm>
            <a:prstGeom prst="flowChartMagneticDisk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1">
                <a:solidFill>
                  <a:prstClr val="white"/>
                </a:solidFill>
              </a:endParaRPr>
            </a:p>
          </p:txBody>
        </p:sp>
      </p:grpSp>
      <p:grpSp>
        <p:nvGrpSpPr>
          <p:cNvPr id="199" name="Group 198"/>
          <p:cNvGrpSpPr/>
          <p:nvPr/>
        </p:nvGrpSpPr>
        <p:grpSpPr>
          <a:xfrm>
            <a:off x="5295618" y="3317698"/>
            <a:ext cx="1511476" cy="465515"/>
            <a:chOff x="5570499" y="2804011"/>
            <a:chExt cx="2015302" cy="620686"/>
          </a:xfrm>
        </p:grpSpPr>
        <p:grpSp>
          <p:nvGrpSpPr>
            <p:cNvPr id="200" name="Group 199"/>
            <p:cNvGrpSpPr/>
            <p:nvPr/>
          </p:nvGrpSpPr>
          <p:grpSpPr>
            <a:xfrm rot="11766775">
              <a:off x="6164368" y="3208289"/>
              <a:ext cx="256628" cy="192454"/>
              <a:chOff x="4878896" y="4468974"/>
              <a:chExt cx="252661" cy="192454"/>
            </a:xfrm>
          </p:grpSpPr>
          <p:sp>
            <p:nvSpPr>
              <p:cNvPr id="222" name="Freeform 221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  <p:sp>
            <p:nvSpPr>
              <p:cNvPr id="223" name="Oval 222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201" name="Group 200"/>
            <p:cNvGrpSpPr/>
            <p:nvPr/>
          </p:nvGrpSpPr>
          <p:grpSpPr>
            <a:xfrm rot="11181539">
              <a:off x="5611182" y="3179702"/>
              <a:ext cx="256628" cy="192454"/>
              <a:chOff x="4878896" y="4468974"/>
              <a:chExt cx="252661" cy="192454"/>
            </a:xfrm>
          </p:grpSpPr>
          <p:sp>
            <p:nvSpPr>
              <p:cNvPr id="220" name="Freeform 219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  <p:sp>
            <p:nvSpPr>
              <p:cNvPr id="221" name="Oval 220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202" name="Group 201"/>
            <p:cNvGrpSpPr/>
            <p:nvPr/>
          </p:nvGrpSpPr>
          <p:grpSpPr>
            <a:xfrm>
              <a:off x="5887775" y="3202359"/>
              <a:ext cx="256628" cy="192454"/>
              <a:chOff x="4878896" y="4468974"/>
              <a:chExt cx="252661" cy="192454"/>
            </a:xfrm>
          </p:grpSpPr>
          <p:sp>
            <p:nvSpPr>
              <p:cNvPr id="218" name="Freeform 217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  <p:sp>
            <p:nvSpPr>
              <p:cNvPr id="219" name="Oval 218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203" name="Group 202"/>
            <p:cNvGrpSpPr/>
            <p:nvPr/>
          </p:nvGrpSpPr>
          <p:grpSpPr>
            <a:xfrm rot="19578349">
              <a:off x="6440961" y="3219866"/>
              <a:ext cx="256628" cy="192454"/>
              <a:chOff x="4878896" y="4468974"/>
              <a:chExt cx="252661" cy="192454"/>
            </a:xfrm>
          </p:grpSpPr>
          <p:sp>
            <p:nvSpPr>
              <p:cNvPr id="216" name="Freeform 215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  <p:sp>
            <p:nvSpPr>
              <p:cNvPr id="217" name="Oval 216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204" name="Group 203"/>
            <p:cNvGrpSpPr/>
            <p:nvPr/>
          </p:nvGrpSpPr>
          <p:grpSpPr>
            <a:xfrm rot="8793276">
              <a:off x="6717554" y="3210077"/>
              <a:ext cx="256628" cy="192454"/>
              <a:chOff x="4878896" y="4468974"/>
              <a:chExt cx="252661" cy="192454"/>
            </a:xfrm>
          </p:grpSpPr>
          <p:sp>
            <p:nvSpPr>
              <p:cNvPr id="214" name="Freeform 213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  <p:sp>
            <p:nvSpPr>
              <p:cNvPr id="215" name="Oval 214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205" name="Group 204"/>
            <p:cNvGrpSpPr/>
            <p:nvPr/>
          </p:nvGrpSpPr>
          <p:grpSpPr>
            <a:xfrm rot="19708783">
              <a:off x="6994147" y="3217792"/>
              <a:ext cx="256628" cy="192454"/>
              <a:chOff x="4878896" y="4468974"/>
              <a:chExt cx="252661" cy="192454"/>
            </a:xfrm>
          </p:grpSpPr>
          <p:sp>
            <p:nvSpPr>
              <p:cNvPr id="212" name="Freeform 211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  <p:sp>
            <p:nvSpPr>
              <p:cNvPr id="213" name="Oval 212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206" name="Group 205"/>
            <p:cNvGrpSpPr/>
            <p:nvPr/>
          </p:nvGrpSpPr>
          <p:grpSpPr>
            <a:xfrm rot="20706418">
              <a:off x="7270739" y="3206218"/>
              <a:ext cx="256628" cy="192454"/>
              <a:chOff x="4878896" y="4468974"/>
              <a:chExt cx="252661" cy="192454"/>
            </a:xfrm>
          </p:grpSpPr>
          <p:sp>
            <p:nvSpPr>
              <p:cNvPr id="210" name="Freeform 209"/>
              <p:cNvSpPr/>
              <p:nvPr/>
            </p:nvSpPr>
            <p:spPr>
              <a:xfrm>
                <a:off x="4878896" y="4468974"/>
                <a:ext cx="252661" cy="192454"/>
              </a:xfrm>
              <a:custGeom>
                <a:avLst/>
                <a:gdLst>
                  <a:gd name="connsiteX0" fmla="*/ 232012 w 443552"/>
                  <a:gd name="connsiteY0" fmla="*/ 48436 h 430573"/>
                  <a:gd name="connsiteX1" fmla="*/ 232012 w 443552"/>
                  <a:gd name="connsiteY1" fmla="*/ 48436 h 430573"/>
                  <a:gd name="connsiteX2" fmla="*/ 348018 w 443552"/>
                  <a:gd name="connsiteY2" fmla="*/ 21140 h 430573"/>
                  <a:gd name="connsiteX3" fmla="*/ 368490 w 443552"/>
                  <a:gd name="connsiteY3" fmla="*/ 27964 h 430573"/>
                  <a:gd name="connsiteX4" fmla="*/ 382137 w 443552"/>
                  <a:gd name="connsiteY4" fmla="*/ 48436 h 430573"/>
                  <a:gd name="connsiteX5" fmla="*/ 395785 w 443552"/>
                  <a:gd name="connsiteY5" fmla="*/ 89379 h 430573"/>
                  <a:gd name="connsiteX6" fmla="*/ 395785 w 443552"/>
                  <a:gd name="connsiteY6" fmla="*/ 137146 h 430573"/>
                  <a:gd name="connsiteX7" fmla="*/ 416257 w 443552"/>
                  <a:gd name="connsiteY7" fmla="*/ 150794 h 430573"/>
                  <a:gd name="connsiteX8" fmla="*/ 429904 w 443552"/>
                  <a:gd name="connsiteY8" fmla="*/ 171266 h 430573"/>
                  <a:gd name="connsiteX9" fmla="*/ 443552 w 443552"/>
                  <a:gd name="connsiteY9" fmla="*/ 212209 h 430573"/>
                  <a:gd name="connsiteX10" fmla="*/ 436728 w 443552"/>
                  <a:gd name="connsiteY10" fmla="*/ 280448 h 430573"/>
                  <a:gd name="connsiteX11" fmla="*/ 429904 w 443552"/>
                  <a:gd name="connsiteY11" fmla="*/ 300920 h 430573"/>
                  <a:gd name="connsiteX12" fmla="*/ 409433 w 443552"/>
                  <a:gd name="connsiteY12" fmla="*/ 307743 h 430573"/>
                  <a:gd name="connsiteX13" fmla="*/ 388961 w 443552"/>
                  <a:gd name="connsiteY13" fmla="*/ 348687 h 430573"/>
                  <a:gd name="connsiteX14" fmla="*/ 382137 w 443552"/>
                  <a:gd name="connsiteY14" fmla="*/ 369158 h 430573"/>
                  <a:gd name="connsiteX15" fmla="*/ 334370 w 443552"/>
                  <a:gd name="connsiteY15" fmla="*/ 423749 h 430573"/>
                  <a:gd name="connsiteX16" fmla="*/ 313898 w 443552"/>
                  <a:gd name="connsiteY16" fmla="*/ 430573 h 430573"/>
                  <a:gd name="connsiteX17" fmla="*/ 252484 w 443552"/>
                  <a:gd name="connsiteY17" fmla="*/ 416926 h 430573"/>
                  <a:gd name="connsiteX18" fmla="*/ 218364 w 443552"/>
                  <a:gd name="connsiteY18" fmla="*/ 382806 h 430573"/>
                  <a:gd name="connsiteX19" fmla="*/ 122830 w 443552"/>
                  <a:gd name="connsiteY19" fmla="*/ 375982 h 430573"/>
                  <a:gd name="connsiteX20" fmla="*/ 95534 w 443552"/>
                  <a:gd name="connsiteY20" fmla="*/ 369158 h 430573"/>
                  <a:gd name="connsiteX21" fmla="*/ 68239 w 443552"/>
                  <a:gd name="connsiteY21" fmla="*/ 307743 h 430573"/>
                  <a:gd name="connsiteX22" fmla="*/ 61415 w 443552"/>
                  <a:gd name="connsiteY22" fmla="*/ 287272 h 430573"/>
                  <a:gd name="connsiteX23" fmla="*/ 68239 w 443552"/>
                  <a:gd name="connsiteY23" fmla="*/ 239505 h 430573"/>
                  <a:gd name="connsiteX24" fmla="*/ 34119 w 443552"/>
                  <a:gd name="connsiteY24" fmla="*/ 178090 h 430573"/>
                  <a:gd name="connsiteX25" fmla="*/ 20472 w 443552"/>
                  <a:gd name="connsiteY25" fmla="*/ 157618 h 430573"/>
                  <a:gd name="connsiteX26" fmla="*/ 6824 w 443552"/>
                  <a:gd name="connsiteY26" fmla="*/ 137146 h 430573"/>
                  <a:gd name="connsiteX27" fmla="*/ 0 w 443552"/>
                  <a:gd name="connsiteY27" fmla="*/ 116675 h 430573"/>
                  <a:gd name="connsiteX28" fmla="*/ 6824 w 443552"/>
                  <a:gd name="connsiteY28" fmla="*/ 89379 h 430573"/>
                  <a:gd name="connsiteX29" fmla="*/ 88710 w 443552"/>
                  <a:gd name="connsiteY29" fmla="*/ 62084 h 430573"/>
                  <a:gd name="connsiteX30" fmla="*/ 109182 w 443552"/>
                  <a:gd name="connsiteY30" fmla="*/ 41612 h 430573"/>
                  <a:gd name="connsiteX31" fmla="*/ 122830 w 443552"/>
                  <a:gd name="connsiteY31" fmla="*/ 21140 h 430573"/>
                  <a:gd name="connsiteX32" fmla="*/ 163773 w 443552"/>
                  <a:gd name="connsiteY32" fmla="*/ 669 h 430573"/>
                  <a:gd name="connsiteX33" fmla="*/ 204716 w 443552"/>
                  <a:gd name="connsiteY33" fmla="*/ 669 h 430573"/>
                  <a:gd name="connsiteX34" fmla="*/ 232012 w 443552"/>
                  <a:gd name="connsiteY34" fmla="*/ 48436 h 43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43552" h="430573">
                    <a:moveTo>
                      <a:pt x="232012" y="48436"/>
                    </a:moveTo>
                    <a:lnTo>
                      <a:pt x="232012" y="48436"/>
                    </a:lnTo>
                    <a:cubicBezTo>
                      <a:pt x="283320" y="29195"/>
                      <a:pt x="291208" y="21140"/>
                      <a:pt x="348018" y="21140"/>
                    </a:cubicBezTo>
                    <a:cubicBezTo>
                      <a:pt x="355211" y="21140"/>
                      <a:pt x="361666" y="25689"/>
                      <a:pt x="368490" y="27964"/>
                    </a:cubicBezTo>
                    <a:cubicBezTo>
                      <a:pt x="373039" y="34788"/>
                      <a:pt x="378806" y="40942"/>
                      <a:pt x="382137" y="48436"/>
                    </a:cubicBezTo>
                    <a:cubicBezTo>
                      <a:pt x="387980" y="61582"/>
                      <a:pt x="395785" y="89379"/>
                      <a:pt x="395785" y="89379"/>
                    </a:cubicBezTo>
                    <a:cubicBezTo>
                      <a:pt x="391471" y="106634"/>
                      <a:pt x="382732" y="120830"/>
                      <a:pt x="395785" y="137146"/>
                    </a:cubicBezTo>
                    <a:cubicBezTo>
                      <a:pt x="400908" y="143550"/>
                      <a:pt x="409433" y="146245"/>
                      <a:pt x="416257" y="150794"/>
                    </a:cubicBezTo>
                    <a:cubicBezTo>
                      <a:pt x="420806" y="157618"/>
                      <a:pt x="426573" y="163772"/>
                      <a:pt x="429904" y="171266"/>
                    </a:cubicBezTo>
                    <a:cubicBezTo>
                      <a:pt x="435747" y="184412"/>
                      <a:pt x="443552" y="212209"/>
                      <a:pt x="443552" y="212209"/>
                    </a:cubicBezTo>
                    <a:cubicBezTo>
                      <a:pt x="441277" y="234955"/>
                      <a:pt x="440204" y="257854"/>
                      <a:pt x="436728" y="280448"/>
                    </a:cubicBezTo>
                    <a:cubicBezTo>
                      <a:pt x="435634" y="287557"/>
                      <a:pt x="434990" y="295834"/>
                      <a:pt x="429904" y="300920"/>
                    </a:cubicBezTo>
                    <a:cubicBezTo>
                      <a:pt x="424818" y="306006"/>
                      <a:pt x="416257" y="305469"/>
                      <a:pt x="409433" y="307743"/>
                    </a:cubicBezTo>
                    <a:cubicBezTo>
                      <a:pt x="392282" y="359197"/>
                      <a:pt x="415417" y="295777"/>
                      <a:pt x="388961" y="348687"/>
                    </a:cubicBezTo>
                    <a:cubicBezTo>
                      <a:pt x="385744" y="355120"/>
                      <a:pt x="385630" y="362870"/>
                      <a:pt x="382137" y="369158"/>
                    </a:cubicBezTo>
                    <a:cubicBezTo>
                      <a:pt x="366388" y="397507"/>
                      <a:pt x="360443" y="410713"/>
                      <a:pt x="334370" y="423749"/>
                    </a:cubicBezTo>
                    <a:cubicBezTo>
                      <a:pt x="327936" y="426966"/>
                      <a:pt x="320722" y="428298"/>
                      <a:pt x="313898" y="430573"/>
                    </a:cubicBezTo>
                    <a:cubicBezTo>
                      <a:pt x="313484" y="430504"/>
                      <a:pt x="261324" y="423998"/>
                      <a:pt x="252484" y="416926"/>
                    </a:cubicBezTo>
                    <a:cubicBezTo>
                      <a:pt x="235316" y="403192"/>
                      <a:pt x="244630" y="387441"/>
                      <a:pt x="218364" y="382806"/>
                    </a:cubicBezTo>
                    <a:cubicBezTo>
                      <a:pt x="186924" y="377258"/>
                      <a:pt x="154675" y="378257"/>
                      <a:pt x="122830" y="375982"/>
                    </a:cubicBezTo>
                    <a:cubicBezTo>
                      <a:pt x="113731" y="373707"/>
                      <a:pt x="103338" y="374360"/>
                      <a:pt x="95534" y="369158"/>
                    </a:cubicBezTo>
                    <a:cubicBezTo>
                      <a:pt x="81631" y="359890"/>
                      <a:pt x="70930" y="315817"/>
                      <a:pt x="68239" y="307743"/>
                    </a:cubicBezTo>
                    <a:lnTo>
                      <a:pt x="61415" y="287272"/>
                    </a:lnTo>
                    <a:cubicBezTo>
                      <a:pt x="63690" y="271350"/>
                      <a:pt x="68239" y="255589"/>
                      <a:pt x="68239" y="239505"/>
                    </a:cubicBezTo>
                    <a:cubicBezTo>
                      <a:pt x="68239" y="221488"/>
                      <a:pt x="38016" y="183936"/>
                      <a:pt x="34119" y="178090"/>
                    </a:cubicBezTo>
                    <a:lnTo>
                      <a:pt x="20472" y="157618"/>
                    </a:lnTo>
                    <a:cubicBezTo>
                      <a:pt x="15923" y="150794"/>
                      <a:pt x="9418" y="144927"/>
                      <a:pt x="6824" y="137146"/>
                    </a:cubicBezTo>
                    <a:lnTo>
                      <a:pt x="0" y="116675"/>
                    </a:lnTo>
                    <a:cubicBezTo>
                      <a:pt x="2275" y="107576"/>
                      <a:pt x="4247" y="98397"/>
                      <a:pt x="6824" y="89379"/>
                    </a:cubicBezTo>
                    <a:cubicBezTo>
                      <a:pt x="19427" y="45271"/>
                      <a:pt x="14052" y="68871"/>
                      <a:pt x="88710" y="62084"/>
                    </a:cubicBezTo>
                    <a:cubicBezTo>
                      <a:pt x="95534" y="55260"/>
                      <a:pt x="103004" y="49026"/>
                      <a:pt x="109182" y="41612"/>
                    </a:cubicBezTo>
                    <a:cubicBezTo>
                      <a:pt x="114432" y="35311"/>
                      <a:pt x="117031" y="26939"/>
                      <a:pt x="122830" y="21140"/>
                    </a:cubicBezTo>
                    <a:cubicBezTo>
                      <a:pt x="131312" y="12658"/>
                      <a:pt x="151286" y="2056"/>
                      <a:pt x="163773" y="669"/>
                    </a:cubicBezTo>
                    <a:cubicBezTo>
                      <a:pt x="177337" y="-838"/>
                      <a:pt x="191068" y="669"/>
                      <a:pt x="204716" y="669"/>
                    </a:cubicBezTo>
                    <a:lnTo>
                      <a:pt x="232012" y="48436"/>
                    </a:lnTo>
                    <a:close/>
                  </a:path>
                </a:pathLst>
              </a:custGeom>
              <a:gradFill>
                <a:gsLst>
                  <a:gs pos="0">
                    <a:schemeClr val="bg1"/>
                  </a:gs>
                  <a:gs pos="100000">
                    <a:srgbClr val="6600CC"/>
                  </a:gs>
                </a:gsLst>
                <a:path path="circle">
                  <a:fillToRect l="50000" t="50000" r="50000" b="50000"/>
                </a:path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  <p:sp>
            <p:nvSpPr>
              <p:cNvPr id="211" name="Oval 210"/>
              <p:cNvSpPr/>
              <p:nvPr/>
            </p:nvSpPr>
            <p:spPr>
              <a:xfrm>
                <a:off x="5015060" y="4561889"/>
                <a:ext cx="45719" cy="49342"/>
              </a:xfrm>
              <a:prstGeom prst="ellipse">
                <a:avLst/>
              </a:prstGeom>
              <a:solidFill>
                <a:srgbClr val="6600CC"/>
              </a:solidFill>
              <a:ln w="12700" cap="flat" cmpd="sng" algn="ctr">
                <a:solidFill>
                  <a:srgbClr val="7030A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endParaRPr lang="en-US" sz="1351" kern="0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207" name="Group 206"/>
            <p:cNvGrpSpPr/>
            <p:nvPr/>
          </p:nvGrpSpPr>
          <p:grpSpPr>
            <a:xfrm>
              <a:off x="5570499" y="2804011"/>
              <a:ext cx="2015302" cy="620686"/>
              <a:chOff x="5461863" y="2244398"/>
              <a:chExt cx="2015302" cy="620686"/>
            </a:xfrm>
          </p:grpSpPr>
          <p:cxnSp>
            <p:nvCxnSpPr>
              <p:cNvPr id="208" name="Straight Connector 207"/>
              <p:cNvCxnSpPr/>
              <p:nvPr/>
            </p:nvCxnSpPr>
            <p:spPr>
              <a:xfrm>
                <a:off x="5461863" y="2630941"/>
                <a:ext cx="2015302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209" name="Flowchart: Magnetic Disk 208"/>
              <p:cNvSpPr/>
              <p:nvPr/>
            </p:nvSpPr>
            <p:spPr>
              <a:xfrm>
                <a:off x="5461863" y="2244398"/>
                <a:ext cx="2015302" cy="620686"/>
              </a:xfrm>
              <a:prstGeom prst="flowChartMagneticDisk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>
                  <a:solidFill>
                    <a:prstClr val="white"/>
                  </a:solidFill>
                </a:endParaRPr>
              </a:p>
            </p:txBody>
          </p:sp>
        </p:grpSp>
      </p:grpSp>
      <p:cxnSp>
        <p:nvCxnSpPr>
          <p:cNvPr id="3" name="Straight Arrow Connector 2"/>
          <p:cNvCxnSpPr/>
          <p:nvPr/>
        </p:nvCxnSpPr>
        <p:spPr>
          <a:xfrm flipH="1">
            <a:off x="2655303" y="1177941"/>
            <a:ext cx="10087" cy="21031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Arrow Connector 177"/>
          <p:cNvCxnSpPr/>
          <p:nvPr/>
        </p:nvCxnSpPr>
        <p:spPr>
          <a:xfrm flipH="1">
            <a:off x="5740908" y="2630048"/>
            <a:ext cx="10087" cy="6400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Straight Arrow Connector 178"/>
          <p:cNvCxnSpPr/>
          <p:nvPr/>
        </p:nvCxnSpPr>
        <p:spPr>
          <a:xfrm flipH="1">
            <a:off x="4458573" y="2613719"/>
            <a:ext cx="10087" cy="6400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TextBox 180"/>
          <p:cNvSpPr txBox="1"/>
          <p:nvPr/>
        </p:nvSpPr>
        <p:spPr>
          <a:xfrm>
            <a:off x="1702831" y="3788313"/>
            <a:ext cx="1898148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351" dirty="0" smtClean="0">
                <a:solidFill>
                  <a:prstClr val="black"/>
                </a:solidFill>
              </a:rPr>
              <a:t>Adipocyte mono-culture</a:t>
            </a:r>
            <a:endParaRPr lang="en-US" sz="1351" dirty="0">
              <a:solidFill>
                <a:prstClr val="black"/>
              </a:solidFill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5047476" y="3788313"/>
            <a:ext cx="2074479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351" dirty="0" smtClean="0">
                <a:solidFill>
                  <a:prstClr val="black"/>
                </a:solidFill>
              </a:rPr>
              <a:t>Macrophage mono-culture</a:t>
            </a:r>
            <a:endParaRPr lang="en-US" sz="1351" dirty="0">
              <a:solidFill>
                <a:prstClr val="black"/>
              </a:solidFill>
            </a:endParaRPr>
          </a:p>
        </p:txBody>
      </p:sp>
      <p:sp>
        <p:nvSpPr>
          <p:cNvPr id="183" name="TextBox 182"/>
          <p:cNvSpPr txBox="1"/>
          <p:nvPr/>
        </p:nvSpPr>
        <p:spPr>
          <a:xfrm>
            <a:off x="3933533" y="3788313"/>
            <a:ext cx="921342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351" dirty="0" smtClean="0">
                <a:solidFill>
                  <a:prstClr val="black"/>
                </a:solidFill>
              </a:rPr>
              <a:t>Co-culture</a:t>
            </a:r>
            <a:endParaRPr lang="en-US" sz="1351" dirty="0">
              <a:solidFill>
                <a:prstClr val="black"/>
              </a:solidFill>
            </a:endParaRPr>
          </a:p>
        </p:txBody>
      </p:sp>
      <p:grpSp>
        <p:nvGrpSpPr>
          <p:cNvPr id="187" name="Group 186"/>
          <p:cNvGrpSpPr/>
          <p:nvPr/>
        </p:nvGrpSpPr>
        <p:grpSpPr>
          <a:xfrm>
            <a:off x="6928925" y="6042022"/>
            <a:ext cx="241905" cy="141477"/>
            <a:chOff x="2985363" y="2996832"/>
            <a:chExt cx="322540" cy="188636"/>
          </a:xfrm>
        </p:grpSpPr>
        <p:sp>
          <p:nvSpPr>
            <p:cNvPr id="189" name="Oval 188"/>
            <p:cNvSpPr/>
            <p:nvPr/>
          </p:nvSpPr>
          <p:spPr>
            <a:xfrm>
              <a:off x="2985363" y="2996832"/>
              <a:ext cx="322540" cy="188636"/>
            </a:xfrm>
            <a:prstGeom prst="ellipse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12700" cap="flat" cmpd="sng" algn="ctr">
              <a:solidFill>
                <a:schemeClr val="accent1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  <p:sp>
          <p:nvSpPr>
            <p:cNvPr id="225" name="Oval 224"/>
            <p:cNvSpPr/>
            <p:nvPr/>
          </p:nvSpPr>
          <p:spPr>
            <a:xfrm>
              <a:off x="3144249" y="3057572"/>
              <a:ext cx="90089" cy="88512"/>
            </a:xfrm>
            <a:prstGeom prst="ellipse">
              <a:avLst/>
            </a:prstGeom>
            <a:solidFill>
              <a:srgbClr val="4F81BD">
                <a:lumMod val="20000"/>
                <a:lumOff val="80000"/>
              </a:srgbClr>
            </a:solidFill>
            <a:ln w="12700" cap="flat" cmpd="sng" algn="ctr">
              <a:solidFill>
                <a:srgbClr val="1F497D">
                  <a:lumMod val="20000"/>
                  <a:lumOff val="8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</p:grpSp>
      <p:grpSp>
        <p:nvGrpSpPr>
          <p:cNvPr id="226" name="Group 225"/>
          <p:cNvGrpSpPr/>
          <p:nvPr/>
        </p:nvGrpSpPr>
        <p:grpSpPr>
          <a:xfrm>
            <a:off x="6951854" y="6327833"/>
            <a:ext cx="192471" cy="144341"/>
            <a:chOff x="4878896" y="4468974"/>
            <a:chExt cx="252661" cy="192454"/>
          </a:xfrm>
        </p:grpSpPr>
        <p:sp>
          <p:nvSpPr>
            <p:cNvPr id="227" name="Freeform 226"/>
            <p:cNvSpPr/>
            <p:nvPr/>
          </p:nvSpPr>
          <p:spPr>
            <a:xfrm>
              <a:off x="4878896" y="4468974"/>
              <a:ext cx="252661" cy="192454"/>
            </a:xfrm>
            <a:custGeom>
              <a:avLst/>
              <a:gdLst>
                <a:gd name="connsiteX0" fmla="*/ 232012 w 443552"/>
                <a:gd name="connsiteY0" fmla="*/ 48436 h 430573"/>
                <a:gd name="connsiteX1" fmla="*/ 232012 w 443552"/>
                <a:gd name="connsiteY1" fmla="*/ 48436 h 430573"/>
                <a:gd name="connsiteX2" fmla="*/ 348018 w 443552"/>
                <a:gd name="connsiteY2" fmla="*/ 21140 h 430573"/>
                <a:gd name="connsiteX3" fmla="*/ 368490 w 443552"/>
                <a:gd name="connsiteY3" fmla="*/ 27964 h 430573"/>
                <a:gd name="connsiteX4" fmla="*/ 382137 w 443552"/>
                <a:gd name="connsiteY4" fmla="*/ 48436 h 430573"/>
                <a:gd name="connsiteX5" fmla="*/ 395785 w 443552"/>
                <a:gd name="connsiteY5" fmla="*/ 89379 h 430573"/>
                <a:gd name="connsiteX6" fmla="*/ 395785 w 443552"/>
                <a:gd name="connsiteY6" fmla="*/ 137146 h 430573"/>
                <a:gd name="connsiteX7" fmla="*/ 416257 w 443552"/>
                <a:gd name="connsiteY7" fmla="*/ 150794 h 430573"/>
                <a:gd name="connsiteX8" fmla="*/ 429904 w 443552"/>
                <a:gd name="connsiteY8" fmla="*/ 171266 h 430573"/>
                <a:gd name="connsiteX9" fmla="*/ 443552 w 443552"/>
                <a:gd name="connsiteY9" fmla="*/ 212209 h 430573"/>
                <a:gd name="connsiteX10" fmla="*/ 436728 w 443552"/>
                <a:gd name="connsiteY10" fmla="*/ 280448 h 430573"/>
                <a:gd name="connsiteX11" fmla="*/ 429904 w 443552"/>
                <a:gd name="connsiteY11" fmla="*/ 300920 h 430573"/>
                <a:gd name="connsiteX12" fmla="*/ 409433 w 443552"/>
                <a:gd name="connsiteY12" fmla="*/ 307743 h 430573"/>
                <a:gd name="connsiteX13" fmla="*/ 388961 w 443552"/>
                <a:gd name="connsiteY13" fmla="*/ 348687 h 430573"/>
                <a:gd name="connsiteX14" fmla="*/ 382137 w 443552"/>
                <a:gd name="connsiteY14" fmla="*/ 369158 h 430573"/>
                <a:gd name="connsiteX15" fmla="*/ 334370 w 443552"/>
                <a:gd name="connsiteY15" fmla="*/ 423749 h 430573"/>
                <a:gd name="connsiteX16" fmla="*/ 313898 w 443552"/>
                <a:gd name="connsiteY16" fmla="*/ 430573 h 430573"/>
                <a:gd name="connsiteX17" fmla="*/ 252484 w 443552"/>
                <a:gd name="connsiteY17" fmla="*/ 416926 h 430573"/>
                <a:gd name="connsiteX18" fmla="*/ 218364 w 443552"/>
                <a:gd name="connsiteY18" fmla="*/ 382806 h 430573"/>
                <a:gd name="connsiteX19" fmla="*/ 122830 w 443552"/>
                <a:gd name="connsiteY19" fmla="*/ 375982 h 430573"/>
                <a:gd name="connsiteX20" fmla="*/ 95534 w 443552"/>
                <a:gd name="connsiteY20" fmla="*/ 369158 h 430573"/>
                <a:gd name="connsiteX21" fmla="*/ 68239 w 443552"/>
                <a:gd name="connsiteY21" fmla="*/ 307743 h 430573"/>
                <a:gd name="connsiteX22" fmla="*/ 61415 w 443552"/>
                <a:gd name="connsiteY22" fmla="*/ 287272 h 430573"/>
                <a:gd name="connsiteX23" fmla="*/ 68239 w 443552"/>
                <a:gd name="connsiteY23" fmla="*/ 239505 h 430573"/>
                <a:gd name="connsiteX24" fmla="*/ 34119 w 443552"/>
                <a:gd name="connsiteY24" fmla="*/ 178090 h 430573"/>
                <a:gd name="connsiteX25" fmla="*/ 20472 w 443552"/>
                <a:gd name="connsiteY25" fmla="*/ 157618 h 430573"/>
                <a:gd name="connsiteX26" fmla="*/ 6824 w 443552"/>
                <a:gd name="connsiteY26" fmla="*/ 137146 h 430573"/>
                <a:gd name="connsiteX27" fmla="*/ 0 w 443552"/>
                <a:gd name="connsiteY27" fmla="*/ 116675 h 430573"/>
                <a:gd name="connsiteX28" fmla="*/ 6824 w 443552"/>
                <a:gd name="connsiteY28" fmla="*/ 89379 h 430573"/>
                <a:gd name="connsiteX29" fmla="*/ 88710 w 443552"/>
                <a:gd name="connsiteY29" fmla="*/ 62084 h 430573"/>
                <a:gd name="connsiteX30" fmla="*/ 109182 w 443552"/>
                <a:gd name="connsiteY30" fmla="*/ 41612 h 430573"/>
                <a:gd name="connsiteX31" fmla="*/ 122830 w 443552"/>
                <a:gd name="connsiteY31" fmla="*/ 21140 h 430573"/>
                <a:gd name="connsiteX32" fmla="*/ 163773 w 443552"/>
                <a:gd name="connsiteY32" fmla="*/ 669 h 430573"/>
                <a:gd name="connsiteX33" fmla="*/ 204716 w 443552"/>
                <a:gd name="connsiteY33" fmla="*/ 669 h 430573"/>
                <a:gd name="connsiteX34" fmla="*/ 232012 w 443552"/>
                <a:gd name="connsiteY34" fmla="*/ 48436 h 43057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</a:cxnLst>
              <a:rect l="l" t="t" r="r" b="b"/>
              <a:pathLst>
                <a:path w="443552" h="430573">
                  <a:moveTo>
                    <a:pt x="232012" y="48436"/>
                  </a:moveTo>
                  <a:lnTo>
                    <a:pt x="232012" y="48436"/>
                  </a:lnTo>
                  <a:cubicBezTo>
                    <a:pt x="283320" y="29195"/>
                    <a:pt x="291208" y="21140"/>
                    <a:pt x="348018" y="21140"/>
                  </a:cubicBezTo>
                  <a:cubicBezTo>
                    <a:pt x="355211" y="21140"/>
                    <a:pt x="361666" y="25689"/>
                    <a:pt x="368490" y="27964"/>
                  </a:cubicBezTo>
                  <a:cubicBezTo>
                    <a:pt x="373039" y="34788"/>
                    <a:pt x="378806" y="40942"/>
                    <a:pt x="382137" y="48436"/>
                  </a:cubicBezTo>
                  <a:cubicBezTo>
                    <a:pt x="387980" y="61582"/>
                    <a:pt x="395785" y="89379"/>
                    <a:pt x="395785" y="89379"/>
                  </a:cubicBezTo>
                  <a:cubicBezTo>
                    <a:pt x="391471" y="106634"/>
                    <a:pt x="382732" y="120830"/>
                    <a:pt x="395785" y="137146"/>
                  </a:cubicBezTo>
                  <a:cubicBezTo>
                    <a:pt x="400908" y="143550"/>
                    <a:pt x="409433" y="146245"/>
                    <a:pt x="416257" y="150794"/>
                  </a:cubicBezTo>
                  <a:cubicBezTo>
                    <a:pt x="420806" y="157618"/>
                    <a:pt x="426573" y="163772"/>
                    <a:pt x="429904" y="171266"/>
                  </a:cubicBezTo>
                  <a:cubicBezTo>
                    <a:pt x="435747" y="184412"/>
                    <a:pt x="443552" y="212209"/>
                    <a:pt x="443552" y="212209"/>
                  </a:cubicBezTo>
                  <a:cubicBezTo>
                    <a:pt x="441277" y="234955"/>
                    <a:pt x="440204" y="257854"/>
                    <a:pt x="436728" y="280448"/>
                  </a:cubicBezTo>
                  <a:cubicBezTo>
                    <a:pt x="435634" y="287557"/>
                    <a:pt x="434990" y="295834"/>
                    <a:pt x="429904" y="300920"/>
                  </a:cubicBezTo>
                  <a:cubicBezTo>
                    <a:pt x="424818" y="306006"/>
                    <a:pt x="416257" y="305469"/>
                    <a:pt x="409433" y="307743"/>
                  </a:cubicBezTo>
                  <a:cubicBezTo>
                    <a:pt x="392282" y="359197"/>
                    <a:pt x="415417" y="295777"/>
                    <a:pt x="388961" y="348687"/>
                  </a:cubicBezTo>
                  <a:cubicBezTo>
                    <a:pt x="385744" y="355120"/>
                    <a:pt x="385630" y="362870"/>
                    <a:pt x="382137" y="369158"/>
                  </a:cubicBezTo>
                  <a:cubicBezTo>
                    <a:pt x="366388" y="397507"/>
                    <a:pt x="360443" y="410713"/>
                    <a:pt x="334370" y="423749"/>
                  </a:cubicBezTo>
                  <a:cubicBezTo>
                    <a:pt x="327936" y="426966"/>
                    <a:pt x="320722" y="428298"/>
                    <a:pt x="313898" y="430573"/>
                  </a:cubicBezTo>
                  <a:cubicBezTo>
                    <a:pt x="313484" y="430504"/>
                    <a:pt x="261324" y="423998"/>
                    <a:pt x="252484" y="416926"/>
                  </a:cubicBezTo>
                  <a:cubicBezTo>
                    <a:pt x="235316" y="403192"/>
                    <a:pt x="244630" y="387441"/>
                    <a:pt x="218364" y="382806"/>
                  </a:cubicBezTo>
                  <a:cubicBezTo>
                    <a:pt x="186924" y="377258"/>
                    <a:pt x="154675" y="378257"/>
                    <a:pt x="122830" y="375982"/>
                  </a:cubicBezTo>
                  <a:cubicBezTo>
                    <a:pt x="113731" y="373707"/>
                    <a:pt x="103338" y="374360"/>
                    <a:pt x="95534" y="369158"/>
                  </a:cubicBezTo>
                  <a:cubicBezTo>
                    <a:pt x="81631" y="359890"/>
                    <a:pt x="70930" y="315817"/>
                    <a:pt x="68239" y="307743"/>
                  </a:cubicBezTo>
                  <a:lnTo>
                    <a:pt x="61415" y="287272"/>
                  </a:lnTo>
                  <a:cubicBezTo>
                    <a:pt x="63690" y="271350"/>
                    <a:pt x="68239" y="255589"/>
                    <a:pt x="68239" y="239505"/>
                  </a:cubicBezTo>
                  <a:cubicBezTo>
                    <a:pt x="68239" y="221488"/>
                    <a:pt x="38016" y="183936"/>
                    <a:pt x="34119" y="178090"/>
                  </a:cubicBezTo>
                  <a:lnTo>
                    <a:pt x="20472" y="157618"/>
                  </a:lnTo>
                  <a:cubicBezTo>
                    <a:pt x="15923" y="150794"/>
                    <a:pt x="9418" y="144927"/>
                    <a:pt x="6824" y="137146"/>
                  </a:cubicBezTo>
                  <a:lnTo>
                    <a:pt x="0" y="116675"/>
                  </a:lnTo>
                  <a:cubicBezTo>
                    <a:pt x="2275" y="107576"/>
                    <a:pt x="4247" y="98397"/>
                    <a:pt x="6824" y="89379"/>
                  </a:cubicBezTo>
                  <a:cubicBezTo>
                    <a:pt x="19427" y="45271"/>
                    <a:pt x="14052" y="68871"/>
                    <a:pt x="88710" y="62084"/>
                  </a:cubicBezTo>
                  <a:cubicBezTo>
                    <a:pt x="95534" y="55260"/>
                    <a:pt x="103004" y="49026"/>
                    <a:pt x="109182" y="41612"/>
                  </a:cubicBezTo>
                  <a:cubicBezTo>
                    <a:pt x="114432" y="35311"/>
                    <a:pt x="117031" y="26939"/>
                    <a:pt x="122830" y="21140"/>
                  </a:cubicBezTo>
                  <a:cubicBezTo>
                    <a:pt x="131312" y="12658"/>
                    <a:pt x="151286" y="2056"/>
                    <a:pt x="163773" y="669"/>
                  </a:cubicBezTo>
                  <a:cubicBezTo>
                    <a:pt x="177337" y="-838"/>
                    <a:pt x="191068" y="669"/>
                    <a:pt x="204716" y="669"/>
                  </a:cubicBezTo>
                  <a:lnTo>
                    <a:pt x="232012" y="48436"/>
                  </a:lnTo>
                  <a:close/>
                </a:path>
              </a:pathLst>
            </a:custGeom>
            <a:gradFill>
              <a:gsLst>
                <a:gs pos="0">
                  <a:schemeClr val="bg1"/>
                </a:gs>
                <a:gs pos="100000">
                  <a:srgbClr val="6600CC"/>
                </a:gs>
              </a:gsLst>
              <a:path path="circle">
                <a:fillToRect l="50000" t="50000" r="50000" b="50000"/>
              </a:path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1" dirty="0">
                <a:solidFill>
                  <a:prstClr val="white"/>
                </a:solidFill>
              </a:endParaRPr>
            </a:p>
          </p:txBody>
        </p:sp>
        <p:sp>
          <p:nvSpPr>
            <p:cNvPr id="228" name="Oval 227"/>
            <p:cNvSpPr/>
            <p:nvPr/>
          </p:nvSpPr>
          <p:spPr>
            <a:xfrm>
              <a:off x="5015060" y="4561889"/>
              <a:ext cx="45719" cy="49342"/>
            </a:xfrm>
            <a:prstGeom prst="ellipse">
              <a:avLst/>
            </a:prstGeom>
            <a:solidFill>
              <a:srgbClr val="6600CC"/>
            </a:solidFill>
            <a:ln w="12700" cap="flat" cmpd="sng" algn="ctr">
              <a:solidFill>
                <a:srgbClr val="7030A0"/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sz="1351" kern="0" dirty="0">
                <a:solidFill>
                  <a:prstClr val="white"/>
                </a:solidFill>
              </a:endParaRPr>
            </a:p>
          </p:txBody>
        </p:sp>
      </p:grpSp>
      <p:sp>
        <p:nvSpPr>
          <p:cNvPr id="229" name="TextBox 228"/>
          <p:cNvSpPr txBox="1"/>
          <p:nvPr/>
        </p:nvSpPr>
        <p:spPr>
          <a:xfrm>
            <a:off x="6912794" y="5540910"/>
            <a:ext cx="693010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351" b="1" dirty="0" smtClean="0">
                <a:solidFill>
                  <a:prstClr val="black"/>
                </a:solidFill>
              </a:rPr>
              <a:t>Legend</a:t>
            </a:r>
            <a:endParaRPr lang="en-US" sz="1351" b="1" dirty="0">
              <a:solidFill>
                <a:prstClr val="black"/>
              </a:solidFill>
            </a:endParaRPr>
          </a:p>
        </p:txBody>
      </p:sp>
      <p:sp>
        <p:nvSpPr>
          <p:cNvPr id="230" name="TextBox 229"/>
          <p:cNvSpPr txBox="1"/>
          <p:nvPr/>
        </p:nvSpPr>
        <p:spPr>
          <a:xfrm>
            <a:off x="7223758" y="5962655"/>
            <a:ext cx="909544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351" dirty="0" smtClean="0">
                <a:solidFill>
                  <a:prstClr val="black"/>
                </a:solidFill>
              </a:rPr>
              <a:t>Adipocyte</a:t>
            </a:r>
            <a:endParaRPr lang="en-US" sz="1351" dirty="0">
              <a:solidFill>
                <a:prstClr val="black"/>
              </a:solidFill>
            </a:endParaRPr>
          </a:p>
        </p:txBody>
      </p:sp>
      <p:sp>
        <p:nvSpPr>
          <p:cNvPr id="231" name="TextBox 230"/>
          <p:cNvSpPr txBox="1"/>
          <p:nvPr/>
        </p:nvSpPr>
        <p:spPr>
          <a:xfrm>
            <a:off x="7226500" y="6240785"/>
            <a:ext cx="1071704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351" dirty="0" smtClean="0">
                <a:solidFill>
                  <a:prstClr val="black"/>
                </a:solidFill>
              </a:rPr>
              <a:t>Macrophage</a:t>
            </a:r>
            <a:endParaRPr lang="en-US" sz="1351" dirty="0">
              <a:solidFill>
                <a:prstClr val="black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345238" y="4514850"/>
            <a:ext cx="4057201" cy="113460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32" name="Straight Arrow Connector 231"/>
          <p:cNvCxnSpPr/>
          <p:nvPr/>
        </p:nvCxnSpPr>
        <p:spPr>
          <a:xfrm flipH="1">
            <a:off x="2649072" y="4064348"/>
            <a:ext cx="10087" cy="36576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Straight Arrow Connector 232"/>
          <p:cNvCxnSpPr/>
          <p:nvPr/>
        </p:nvCxnSpPr>
        <p:spPr>
          <a:xfrm flipH="1">
            <a:off x="4401672" y="4064348"/>
            <a:ext cx="10087" cy="36576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Straight Arrow Connector 233"/>
          <p:cNvCxnSpPr/>
          <p:nvPr/>
        </p:nvCxnSpPr>
        <p:spPr>
          <a:xfrm flipH="1">
            <a:off x="5740908" y="4064348"/>
            <a:ext cx="10087" cy="36576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>
            <a:off x="6855238" y="5462278"/>
            <a:ext cx="2183289" cy="123497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" name="Straight Connector 9"/>
          <p:cNvCxnSpPr/>
          <p:nvPr/>
        </p:nvCxnSpPr>
        <p:spPr>
          <a:xfrm>
            <a:off x="6951854" y="5841120"/>
            <a:ext cx="192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5" name="TextBox 234"/>
          <p:cNvSpPr txBox="1"/>
          <p:nvPr/>
        </p:nvSpPr>
        <p:spPr>
          <a:xfrm>
            <a:off x="206241" y="6405152"/>
            <a:ext cx="6383351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351" dirty="0" smtClean="0">
                <a:solidFill>
                  <a:prstClr val="black"/>
                </a:solidFill>
              </a:rPr>
              <a:t>*</a:t>
            </a:r>
            <a:r>
              <a:rPr lang="en-US" sz="1351" b="1" dirty="0" smtClean="0">
                <a:solidFill>
                  <a:prstClr val="black"/>
                </a:solidFill>
              </a:rPr>
              <a:t>Note: </a:t>
            </a:r>
            <a:r>
              <a:rPr lang="en-US" sz="1351" dirty="0" smtClean="0">
                <a:solidFill>
                  <a:prstClr val="black"/>
                </a:solidFill>
              </a:rPr>
              <a:t>The experimental procedure was performed for both white and brown adipocyte.</a:t>
            </a:r>
            <a:endParaRPr lang="en-US" sz="135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855251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436</TotalTime>
  <Words>80</Words>
  <Application>Microsoft Office PowerPoint</Application>
  <PresentationFormat>Letter Paper (8.5x11 in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hampaseuth Thapa</dc:creator>
  <cp:lastModifiedBy>Khampaseuth Thapa</cp:lastModifiedBy>
  <cp:revision>209</cp:revision>
  <dcterms:created xsi:type="dcterms:W3CDTF">2016-02-17T17:41:17Z</dcterms:created>
  <dcterms:modified xsi:type="dcterms:W3CDTF">2017-02-27T19:45:17Z</dcterms:modified>
</cp:coreProperties>
</file>